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7102475" cy="10234613"/>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FF41AED8-DE21-4F99-B07F-387A42F151F8}"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219F2EFD-C52F-4297-807E-5988A46C1ECE}"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D2C6DE7F-2069-4C5C-A8D5-7936DCAA9690}"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137F5B2A-D3DB-4780-816E-1E5750C30D94}"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034B0B74-B251-4706-8833-961EF9956E12}"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0992E869-2EF3-4171-8916-FB6263439307}"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B0011491-D6EA-4C2C-9206-D52425357808}"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FEC39AF9-EA01-4C59-8DAF-F954434FB84D}"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F3809A51-2E6F-41AD-969E-20679333A0B9}"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F59B720-F51C-4FF1-B9AB-B69BD6B030AD}"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27879224-ECB7-4F49-90A9-1CAF56C94B77}"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8F058D9-24C5-480B-A158-0A75B08FE5F0}"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GB"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07DD3B3A-F8FA-44B4-AA05-9FE07C9A810D}" type="slidenum">
              <a:rPr b="0" lang="en-GB"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41" name="Group 3"/>
          <p:cNvGrpSpPr/>
          <p:nvPr/>
        </p:nvGrpSpPr>
        <p:grpSpPr>
          <a:xfrm>
            <a:off x="611280" y="333360"/>
            <a:ext cx="8137440" cy="6115320"/>
            <a:chOff x="611280" y="333360"/>
            <a:chExt cx="8137440" cy="6115320"/>
          </a:xfrm>
        </p:grpSpPr>
        <p:pic>
          <p:nvPicPr>
            <p:cNvPr id="42" name="Picture 7" descr=""/>
            <p:cNvPicPr/>
            <p:nvPr/>
          </p:nvPicPr>
          <p:blipFill>
            <a:blip r:embed="rId1"/>
            <a:stretch/>
          </p:blipFill>
          <p:spPr>
            <a:xfrm>
              <a:off x="1403280" y="333360"/>
              <a:ext cx="6267960" cy="5171760"/>
            </a:xfrm>
            <a:prstGeom prst="rect">
              <a:avLst/>
            </a:prstGeom>
            <a:ln w="0">
              <a:noFill/>
            </a:ln>
          </p:spPr>
        </p:pic>
        <p:sp>
          <p:nvSpPr>
            <p:cNvPr id="43" name="TextBox 2"/>
            <p:cNvSpPr/>
            <p:nvPr/>
          </p:nvSpPr>
          <p:spPr>
            <a:xfrm>
              <a:off x="611280" y="5517720"/>
              <a:ext cx="8137440" cy="9309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100" spc="-1" strike="noStrike">
                  <a:solidFill>
                    <a:srgbClr val="000000"/>
                  </a:solidFill>
                  <a:latin typeface="Arial"/>
                </a:rPr>
                <a:t>Supporting information Figure S2.</a:t>
              </a:r>
              <a:r>
                <a:rPr b="0" lang="en-US" sz="1100" spc="-1" strike="noStrike">
                  <a:solidFill>
                    <a:srgbClr val="000000"/>
                  </a:solidFill>
                  <a:latin typeface="Arial"/>
                </a:rPr>
                <a:t> Alignment of the 24 different p22 protein amino acid sequences of Sweet potato chlorotic stunt virus. Groups of isolates containing identical p22 aa sequences are represented each by a single isolate. The aa sites predicted to be under positive selection (black shades) and the 12 unique aa substitutions in isolate MBL16 (arrows) are pointed out. Numbers on top of the alignment indicate the aa positions with reference to SPCSV isolate Ug (AJ428554). Names of isolates from wild plants are in bold. </a:t>
              </a:r>
              <a:endParaRPr b="0" lang="en-US" sz="1100" spc="-1" strike="noStrike">
                <a:solidFill>
                  <a:srgbClr val="000000"/>
                </a:solidFill>
                <a:latin typeface="Arial"/>
              </a:endParaRPr>
            </a:p>
          </p:txBody>
        </p:sp>
      </p:gr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59</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9-11-27T10:23:49Z</dcterms:created>
  <dc:creator>TUGUME</dc:creator>
  <dc:description/>
  <dc:language>en-US</dc:language>
  <cp:lastModifiedBy>jpvalkon</cp:lastModifiedBy>
  <cp:lastPrinted>2013-07-24T08:50:52Z</cp:lastPrinted>
  <dcterms:modified xsi:type="dcterms:W3CDTF">2013-07-24T09:33:56Z</dcterms:modified>
  <cp:revision>17</cp:revision>
  <dc:subject/>
  <dc:title>Slide 1</dc:title>
</cp:coreProperties>
</file>